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1" r:id="rId2"/>
  </p:sldIdLst>
  <p:sldSz cx="16256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89678C-B03B-D7C7-9E7D-537426E1A2A7}" name="Malandrino, Noemi (NIH/NIDDK) [E]" initials="MN([" userId="S::malandrinon2@nih.gov::6200ecad-b2de-428a-8aa5-bb5ca7a5643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E13644-D5DB-4B92-A4D3-5CB16361942D}" v="25" dt="2025-04-13T22:27:10.37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9706" autoAdjust="0"/>
  </p:normalViewPr>
  <p:slideViewPr>
    <p:cSldViewPr snapToGrid="0">
      <p:cViewPr varScale="1">
        <p:scale>
          <a:sx n="72" d="100"/>
          <a:sy n="72" d="100"/>
        </p:scale>
        <p:origin x="4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ung, Stephanie (NIH/NIDDK) [E]" userId="67f14949-e182-4972-adac-385ab37da48c" providerId="ADAL" clId="{96E13644-D5DB-4B92-A4D3-5CB16361942D}"/>
    <pc:docChg chg="undo custSel addSld delSld modSld sldOrd modMainMaster">
      <pc:chgData name="Chung, Stephanie (NIH/NIDDK) [E]" userId="67f14949-e182-4972-adac-385ab37da48c" providerId="ADAL" clId="{96E13644-D5DB-4B92-A4D3-5CB16361942D}" dt="2025-04-13T22:29:25.908" v="309" actId="1037"/>
      <pc:docMkLst>
        <pc:docMk/>
      </pc:docMkLst>
      <pc:sldChg chg="del">
        <pc:chgData name="Chung, Stephanie (NIH/NIDDK) [E]" userId="67f14949-e182-4972-adac-385ab37da48c" providerId="ADAL" clId="{96E13644-D5DB-4B92-A4D3-5CB16361942D}" dt="2025-04-13T21:41:43.462" v="48" actId="47"/>
        <pc:sldMkLst>
          <pc:docMk/>
          <pc:sldMk cId="3185772121" sldId="256"/>
        </pc:sldMkLst>
      </pc:sldChg>
      <pc:sldChg chg="addSp modSp mod">
        <pc:chgData name="Chung, Stephanie (NIH/NIDDK) [E]" userId="67f14949-e182-4972-adac-385ab37da48c" providerId="ADAL" clId="{96E13644-D5DB-4B92-A4D3-5CB16361942D}" dt="2025-04-13T22:20:10.738" v="141" actId="20577"/>
        <pc:sldMkLst>
          <pc:docMk/>
          <pc:sldMk cId="339473622" sldId="257"/>
        </pc:sldMkLst>
        <pc:spChg chg="add mod">
          <ac:chgData name="Chung, Stephanie (NIH/NIDDK) [E]" userId="67f14949-e182-4972-adac-385ab37da48c" providerId="ADAL" clId="{96E13644-D5DB-4B92-A4D3-5CB16361942D}" dt="2025-04-13T22:20:10.738" v="141" actId="20577"/>
          <ac:spMkLst>
            <pc:docMk/>
            <pc:sldMk cId="339473622" sldId="257"/>
            <ac:spMk id="2" creationId="{9663693B-F55A-CDAC-C378-56CBA53D9DE4}"/>
          </ac:spMkLst>
        </pc:spChg>
        <pc:spChg chg="mod">
          <ac:chgData name="Chung, Stephanie (NIH/NIDDK) [E]" userId="67f14949-e182-4972-adac-385ab37da48c" providerId="ADAL" clId="{96E13644-D5DB-4B92-A4D3-5CB16361942D}" dt="2025-04-13T21:43:28.167" v="82" actId="1076"/>
          <ac:spMkLst>
            <pc:docMk/>
            <pc:sldMk cId="339473622" sldId="257"/>
            <ac:spMk id="7" creationId="{2B01782C-6E99-56BA-BA9C-F8C86198644E}"/>
          </ac:spMkLst>
        </pc:spChg>
        <pc:spChg chg="mod">
          <ac:chgData name="Chung, Stephanie (NIH/NIDDK) [E]" userId="67f14949-e182-4972-adac-385ab37da48c" providerId="ADAL" clId="{96E13644-D5DB-4B92-A4D3-5CB16361942D}" dt="2025-04-13T21:43:32.202" v="83" actId="1076"/>
          <ac:spMkLst>
            <pc:docMk/>
            <pc:sldMk cId="339473622" sldId="257"/>
            <ac:spMk id="8" creationId="{88E66ECA-B188-B356-44BE-250389158930}"/>
          </ac:spMkLst>
        </pc:spChg>
        <pc:spChg chg="mod">
          <ac:chgData name="Chung, Stephanie (NIH/NIDDK) [E]" userId="67f14949-e182-4972-adac-385ab37da48c" providerId="ADAL" clId="{96E13644-D5DB-4B92-A4D3-5CB16361942D}" dt="2025-04-13T21:42:56.783" v="62" actId="255"/>
          <ac:spMkLst>
            <pc:docMk/>
            <pc:sldMk cId="339473622" sldId="257"/>
            <ac:spMk id="9" creationId="{AD5D6E57-B7C1-369F-BE94-62265A311093}"/>
          </ac:spMkLst>
        </pc:spChg>
        <pc:spChg chg="mod">
          <ac:chgData name="Chung, Stephanie (NIH/NIDDK) [E]" userId="67f14949-e182-4972-adac-385ab37da48c" providerId="ADAL" clId="{96E13644-D5DB-4B92-A4D3-5CB16361942D}" dt="2025-04-13T21:42:56.783" v="62" actId="255"/>
          <ac:spMkLst>
            <pc:docMk/>
            <pc:sldMk cId="339473622" sldId="257"/>
            <ac:spMk id="10" creationId="{DDEF32CA-CBE9-3FD4-2607-30760EDF2981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1" creationId="{33728CDF-00A3-FEF2-2E96-71E548F96294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2" creationId="{3679A2E2-3C81-B8E8-C4C3-CA08E89FAD3A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3" creationId="{A311E4F1-3FAA-25B8-672C-5D788F62D610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4" creationId="{D120177A-BA0C-8DFE-9E14-243DFC8911FF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5" creationId="{EE26375E-52F1-73D6-A079-60EF75E85934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6" creationId="{6068CC3C-4E0B-068D-2635-B8A6BF614B57}"/>
          </ac:spMkLst>
        </pc:spChg>
        <pc:spChg chg="mod">
          <ac:chgData name="Chung, Stephanie (NIH/NIDDK) [E]" userId="67f14949-e182-4972-adac-385ab37da48c" providerId="ADAL" clId="{96E13644-D5DB-4B92-A4D3-5CB16361942D}" dt="2025-04-13T21:43:17.948" v="81" actId="1036"/>
          <ac:spMkLst>
            <pc:docMk/>
            <pc:sldMk cId="339473622" sldId="257"/>
            <ac:spMk id="17" creationId="{26971B49-9D11-A101-20D4-DE965E4A69CA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8" creationId="{38C0DB9D-95DD-1C98-FDF0-409C4F4930B0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19" creationId="{A6D07B09-94FA-1B0D-D262-48025339D386}"/>
          </ac:spMkLst>
        </pc:spChg>
        <pc:spChg chg="mod">
          <ac:chgData name="Chung, Stephanie (NIH/NIDDK) [E]" userId="67f14949-e182-4972-adac-385ab37da48c" providerId="ADAL" clId="{96E13644-D5DB-4B92-A4D3-5CB16361942D}" dt="2025-04-13T21:42:48.781" v="59" actId="255"/>
          <ac:spMkLst>
            <pc:docMk/>
            <pc:sldMk cId="339473622" sldId="257"/>
            <ac:spMk id="20" creationId="{2AFCE003-8882-6603-BA06-10F182C699C3}"/>
          </ac:spMkLst>
        </pc:spChg>
        <pc:picChg chg="mod">
          <ac:chgData name="Chung, Stephanie (NIH/NIDDK) [E]" userId="67f14949-e182-4972-adac-385ab37da48c" providerId="ADAL" clId="{96E13644-D5DB-4B92-A4D3-5CB16361942D}" dt="2025-04-13T21:42:22.124" v="54" actId="14100"/>
          <ac:picMkLst>
            <pc:docMk/>
            <pc:sldMk cId="339473622" sldId="257"/>
            <ac:picMk id="5" creationId="{F2C1DD1C-A1AB-B702-9705-2628BA40E8D8}"/>
          </ac:picMkLst>
        </pc:picChg>
        <pc:picChg chg="mod">
          <ac:chgData name="Chung, Stephanie (NIH/NIDDK) [E]" userId="67f14949-e182-4972-adac-385ab37da48c" providerId="ADAL" clId="{96E13644-D5DB-4B92-A4D3-5CB16361942D}" dt="2025-04-13T21:42:22.124" v="54" actId="14100"/>
          <ac:picMkLst>
            <pc:docMk/>
            <pc:sldMk cId="339473622" sldId="257"/>
            <ac:picMk id="6" creationId="{428ECA73-FDFF-3B56-167D-5944DEC98D44}"/>
          </ac:picMkLst>
        </pc:picChg>
      </pc:sldChg>
      <pc:sldChg chg="addSp delSp modSp mod">
        <pc:chgData name="Chung, Stephanie (NIH/NIDDK) [E]" userId="67f14949-e182-4972-adac-385ab37da48c" providerId="ADAL" clId="{96E13644-D5DB-4B92-A4D3-5CB16361942D}" dt="2025-04-13T22:19:13.020" v="131" actId="1076"/>
        <pc:sldMkLst>
          <pc:docMk/>
          <pc:sldMk cId="3255338901" sldId="258"/>
        </pc:sldMkLst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2" creationId="{4F1DFA6D-46B5-F763-4FFB-A090A7268032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3" creationId="{F7910308-8AD5-D754-6BAB-DFCE8C09EC92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4" creationId="{B6EAE5FA-3298-231B-F92E-4533DF10EC0E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5" creationId="{997DBFC2-C7EB-4B0A-2381-07F1915F70CB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7" creationId="{377E8143-9E7B-F781-0A7C-DF668044A9EB}"/>
          </ac:spMkLst>
        </pc:spChg>
        <pc:spChg chg="del mod">
          <ac:chgData name="Chung, Stephanie (NIH/NIDDK) [E]" userId="67f14949-e182-4972-adac-385ab37da48c" providerId="ADAL" clId="{96E13644-D5DB-4B92-A4D3-5CB16361942D}" dt="2025-04-13T22:18:25.798" v="126" actId="478"/>
          <ac:spMkLst>
            <pc:docMk/>
            <pc:sldMk cId="3255338901" sldId="258"/>
            <ac:spMk id="9" creationId="{01FA53AE-9E69-1DAE-B072-5E6BE10EC457}"/>
          </ac:spMkLst>
        </pc:spChg>
        <pc:spChg chg="add mod">
          <ac:chgData name="Chung, Stephanie (NIH/NIDDK) [E]" userId="67f14949-e182-4972-adac-385ab37da48c" providerId="ADAL" clId="{96E13644-D5DB-4B92-A4D3-5CB16361942D}" dt="2025-04-13T22:09:24.738" v="123" actId="20577"/>
          <ac:spMkLst>
            <pc:docMk/>
            <pc:sldMk cId="3255338901" sldId="258"/>
            <ac:spMk id="10" creationId="{494926D4-8067-46B2-1352-604AF5887EBF}"/>
          </ac:spMkLst>
        </pc:spChg>
        <pc:graphicFrameChg chg="add mod">
          <ac:chgData name="Chung, Stephanie (NIH/NIDDK) [E]" userId="67f14949-e182-4972-adac-385ab37da48c" providerId="ADAL" clId="{96E13644-D5DB-4B92-A4D3-5CB16361942D}" dt="2025-04-13T22:19:13.020" v="131" actId="1076"/>
          <ac:graphicFrameMkLst>
            <pc:docMk/>
            <pc:sldMk cId="3255338901" sldId="258"/>
            <ac:graphicFrameMk id="11" creationId="{B2010027-5A62-59EA-33D1-6999ED943C4C}"/>
          </ac:graphicFrameMkLst>
        </pc:graphicFrameChg>
        <pc:picChg chg="del mod">
          <ac:chgData name="Chung, Stephanie (NIH/NIDDK) [E]" userId="67f14949-e182-4972-adac-385ab37da48c" providerId="ADAL" clId="{96E13644-D5DB-4B92-A4D3-5CB16361942D}" dt="2025-04-13T22:18:25.798" v="126" actId="478"/>
          <ac:picMkLst>
            <pc:docMk/>
            <pc:sldMk cId="3255338901" sldId="258"/>
            <ac:picMk id="6" creationId="{3B779D81-A94C-6F86-259D-66A6FBDCA152}"/>
          </ac:picMkLst>
        </pc:picChg>
        <pc:picChg chg="del mod">
          <ac:chgData name="Chung, Stephanie (NIH/NIDDK) [E]" userId="67f14949-e182-4972-adac-385ab37da48c" providerId="ADAL" clId="{96E13644-D5DB-4B92-A4D3-5CB16361942D}" dt="2025-04-13T22:18:25.798" v="126" actId="478"/>
          <ac:picMkLst>
            <pc:docMk/>
            <pc:sldMk cId="3255338901" sldId="258"/>
            <ac:picMk id="8" creationId="{5BF5214B-23BF-DEE8-298A-610B21825B13}"/>
          </ac:picMkLst>
        </pc:picChg>
        <pc:picChg chg="del">
          <ac:chgData name="Chung, Stephanie (NIH/NIDDK) [E]" userId="67f14949-e182-4972-adac-385ab37da48c" providerId="ADAL" clId="{96E13644-D5DB-4B92-A4D3-5CB16361942D}" dt="2025-04-13T21:41:28.568" v="45" actId="478"/>
          <ac:picMkLst>
            <pc:docMk/>
            <pc:sldMk cId="3255338901" sldId="258"/>
            <ac:picMk id="13" creationId="{CE7A8BDB-9279-CF89-1E96-103EA7A43530}"/>
          </ac:picMkLst>
        </pc:picChg>
        <pc:picChg chg="del">
          <ac:chgData name="Chung, Stephanie (NIH/NIDDK) [E]" userId="67f14949-e182-4972-adac-385ab37da48c" providerId="ADAL" clId="{96E13644-D5DB-4B92-A4D3-5CB16361942D}" dt="2025-04-13T21:41:28.568" v="45" actId="478"/>
          <ac:picMkLst>
            <pc:docMk/>
            <pc:sldMk cId="3255338901" sldId="258"/>
            <ac:picMk id="17" creationId="{8337F1A9-20B3-3FA9-81FD-DEA1A33E49F3}"/>
          </ac:picMkLst>
        </pc:picChg>
      </pc:sldChg>
      <pc:sldChg chg="addSp delSp modSp mod">
        <pc:chgData name="Chung, Stephanie (NIH/NIDDK) [E]" userId="67f14949-e182-4972-adac-385ab37da48c" providerId="ADAL" clId="{96E13644-D5DB-4B92-A4D3-5CB16361942D}" dt="2025-04-13T22:09:01.945" v="121" actId="1076"/>
        <pc:sldMkLst>
          <pc:docMk/>
          <pc:sldMk cId="728344467" sldId="259"/>
        </pc:sldMkLst>
        <pc:spChg chg="add mod">
          <ac:chgData name="Chung, Stephanie (NIH/NIDDK) [E]" userId="67f14949-e182-4972-adac-385ab37da48c" providerId="ADAL" clId="{96E13644-D5DB-4B92-A4D3-5CB16361942D}" dt="2025-04-13T22:08:41.186" v="114" actId="255"/>
          <ac:spMkLst>
            <pc:docMk/>
            <pc:sldMk cId="728344467" sldId="259"/>
            <ac:spMk id="2" creationId="{86D32E72-BA05-19C8-3730-9BB54D49831C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3" creationId="{C9A0BC4A-7397-90D2-5647-9BCF70BF4F12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4" creationId="{E66AE62F-7145-77D2-B3B7-2C3BA315AE05}"/>
          </ac:spMkLst>
        </pc:spChg>
        <pc:spChg chg="add 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5" creationId="{6C57F537-653C-4547-407E-10F46CF3C9F6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6" creationId="{043134A2-DC41-6F88-FAA6-D9E623378E3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7" creationId="{9AE3C775-B579-ACF0-A211-9D5DE2DD0AD3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9" creationId="{DF0C8EEE-347C-73A4-9C64-9C4D5E7B065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11" creationId="{AEA0C8C8-B0E3-7F99-26BB-6A7D0B1ADDD7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13" creationId="{348EA720-ED02-16F5-6C1E-072034BD2AAC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2" creationId="{29DE41E2-DBB5-08C9-5A6C-10FD872C36AB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3" creationId="{A8E1D8F2-EE0C-F441-9FF0-7EFD3210D6FE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4" creationId="{B7E661E9-CE80-5434-FD87-00BE1E1C3B05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5" creationId="{0D24159A-E4EC-88C2-D7BA-F8163B2DEBE1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6" creationId="{E01FB4FD-7030-34C2-D779-31BB689CDCF6}"/>
          </ac:spMkLst>
        </pc:spChg>
        <pc:spChg chg="del mod">
          <ac:chgData name="Chung, Stephanie (NIH/NIDDK) [E]" userId="67f14949-e182-4972-adac-385ab37da48c" providerId="ADAL" clId="{96E13644-D5DB-4B92-A4D3-5CB16361942D}" dt="2025-04-13T22:08:16.729" v="99" actId="478"/>
          <ac:spMkLst>
            <pc:docMk/>
            <pc:sldMk cId="728344467" sldId="259"/>
            <ac:spMk id="27" creationId="{EB224A1C-0C1C-9E25-A3DF-B3E0EF045CEA}"/>
          </ac:spMkLst>
        </pc:spChg>
        <pc:graphicFrameChg chg="add mod">
          <ac:chgData name="Chung, Stephanie (NIH/NIDDK) [E]" userId="67f14949-e182-4972-adac-385ab37da48c" providerId="ADAL" clId="{96E13644-D5DB-4B92-A4D3-5CB16361942D}" dt="2025-04-13T22:09:01.945" v="121" actId="1076"/>
          <ac:graphicFrameMkLst>
            <pc:docMk/>
            <pc:sldMk cId="728344467" sldId="259"/>
            <ac:graphicFrameMk id="8" creationId="{730C7FC8-C9E5-0A1E-84D5-AD8C106B899F}"/>
          </ac:graphicFrameMkLst>
        </pc:graphicFrame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6" creationId="{FF08F6D5-28E9-FEE4-A681-040F0F382221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8" creationId="{514AC18E-0BAF-6FCA-1F0D-F5F228F56B62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19" creationId="{23D5E313-78F2-7DEB-7377-DA5676F13EEE}"/>
          </ac:picMkLst>
        </pc:picChg>
        <pc:picChg chg="del mod">
          <ac:chgData name="Chung, Stephanie (NIH/NIDDK) [E]" userId="67f14949-e182-4972-adac-385ab37da48c" providerId="ADAL" clId="{96E13644-D5DB-4B92-A4D3-5CB16361942D}" dt="2025-04-13T22:08:16.729" v="99" actId="478"/>
          <ac:picMkLst>
            <pc:docMk/>
            <pc:sldMk cId="728344467" sldId="259"/>
            <ac:picMk id="20" creationId="{57D048D6-ABD2-5180-F47A-0EFA29BBF2B4}"/>
          </ac:picMkLst>
        </pc:picChg>
      </pc:sldChg>
      <pc:sldChg chg="addSp delSp modSp mod modNotes">
        <pc:chgData name="Chung, Stephanie (NIH/NIDDK) [E]" userId="67f14949-e182-4972-adac-385ab37da48c" providerId="ADAL" clId="{96E13644-D5DB-4B92-A4D3-5CB16361942D}" dt="2025-04-13T22:29:25.908" v="309" actId="1037"/>
        <pc:sldMkLst>
          <pc:docMk/>
          <pc:sldMk cId="690432234" sldId="260"/>
        </pc:sldMkLst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" creationId="{46E9FF08-93F2-330E-E2E3-5A1C8F0F777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" creationId="{ACA969A6-1D0C-CB22-3A90-907B430FEBDA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5" creationId="{3403A9D2-5C86-AB5F-961E-B4F5745B79FA}"/>
          </ac:spMkLst>
        </pc:spChg>
        <pc:spChg chg="add mod">
          <ac:chgData name="Chung, Stephanie (NIH/NIDDK) [E]" userId="67f14949-e182-4972-adac-385ab37da48c" providerId="ADAL" clId="{96E13644-D5DB-4B92-A4D3-5CB16361942D}" dt="2025-04-13T22:20:00.152" v="132"/>
          <ac:spMkLst>
            <pc:docMk/>
            <pc:sldMk cId="690432234" sldId="260"/>
            <ac:spMk id="7" creationId="{08C9EAB6-6DFD-B2B6-EAFC-92AC7D5BADE0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8" creationId="{4276CB35-1E4B-BA3A-354B-EA62FC3F9C0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9" creationId="{91D98B5A-B031-4558-346C-0FD46894425D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11" creationId="{ED98F24D-15E0-C877-3230-803608C7235F}"/>
          </ac:spMkLst>
        </pc:spChg>
        <pc:spChg chg="add mod">
          <ac:chgData name="Chung, Stephanie (NIH/NIDDK) [E]" userId="67f14949-e182-4972-adac-385ab37da48c" providerId="ADAL" clId="{96E13644-D5DB-4B92-A4D3-5CB16361942D}" dt="2025-04-13T22:28:28.831" v="295" actId="14100"/>
          <ac:spMkLst>
            <pc:docMk/>
            <pc:sldMk cId="690432234" sldId="260"/>
            <ac:spMk id="13" creationId="{76642B76-81D1-E8A8-7166-2A64F75224F6}"/>
          </ac:spMkLst>
        </pc:spChg>
        <pc:spChg chg="mod">
          <ac:chgData name="Chung, Stephanie (NIH/NIDDK) [E]" userId="67f14949-e182-4972-adac-385ab37da48c" providerId="ADAL" clId="{96E13644-D5DB-4B92-A4D3-5CB16361942D}" dt="2025-04-13T22:28:48.916" v="297" actId="14100"/>
          <ac:spMkLst>
            <pc:docMk/>
            <pc:sldMk cId="690432234" sldId="260"/>
            <ac:spMk id="15" creationId="{566C72E2-7FEC-C7F9-B9CA-FB775AA3B174}"/>
          </ac:spMkLst>
        </pc:spChg>
        <pc:spChg chg="mod">
          <ac:chgData name="Chung, Stephanie (NIH/NIDDK) [E]" userId="67f14949-e182-4972-adac-385ab37da48c" providerId="ADAL" clId="{96E13644-D5DB-4B92-A4D3-5CB16361942D}" dt="2025-04-13T22:28:54.029" v="298" actId="14100"/>
          <ac:spMkLst>
            <pc:docMk/>
            <pc:sldMk cId="690432234" sldId="260"/>
            <ac:spMk id="18" creationId="{AF115EC8-EBAD-3A00-2149-CA9825852BF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1" creationId="{6A51F51A-787B-3C68-F473-F7EA3C5353F9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2" creationId="{C545EAC8-54EC-CA16-BE2A-9B082AA5469B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23" creationId="{2BADAADD-739C-7ADB-3FEF-C2B5E7E1874E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7" creationId="{22A19288-2202-63B6-9AF6-F64493764D1F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8" creationId="{25FE3C21-2959-676A-F4A3-BCBDA3968049}"/>
          </ac:spMkLst>
        </pc:spChg>
        <pc:spChg chg="add mod">
          <ac:chgData name="Chung, Stephanie (NIH/NIDDK) [E]" userId="67f14949-e182-4972-adac-385ab37da48c" providerId="ADAL" clId="{96E13644-D5DB-4B92-A4D3-5CB16361942D}" dt="2025-04-13T22:29:25.908" v="309" actId="1037"/>
          <ac:spMkLst>
            <pc:docMk/>
            <pc:sldMk cId="690432234" sldId="260"/>
            <ac:spMk id="29" creationId="{D5FB9886-EDF5-A2C8-F2E5-939E3CC651EA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35" creationId="{3A2641FE-EFCD-CFD7-4723-3AC24412B8CF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4" creationId="{F3AB4C42-3FBA-0E3F-4541-76F763E273D4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5" creationId="{79EBE262-F98C-196D-2AB4-EACB81F99C43}"/>
          </ac:spMkLst>
        </pc:spChg>
        <pc:spChg chg="mod">
          <ac:chgData name="Chung, Stephanie (NIH/NIDDK) [E]" userId="67f14949-e182-4972-adac-385ab37da48c" providerId="ADAL" clId="{96E13644-D5DB-4B92-A4D3-5CB16361942D}" dt="2025-04-13T22:28:41.646" v="296" actId="255"/>
          <ac:spMkLst>
            <pc:docMk/>
            <pc:sldMk cId="690432234" sldId="260"/>
            <ac:spMk id="46" creationId="{1CAC2F22-A239-7F74-A9DB-039877E37D41}"/>
          </ac:spMkLst>
        </pc:spChg>
        <pc:spChg chg="mod">
          <ac:chgData name="Chung, Stephanie (NIH/NIDDK) [E]" userId="67f14949-e182-4972-adac-385ab37da48c" providerId="ADAL" clId="{96E13644-D5DB-4B92-A4D3-5CB16361942D}" dt="2025-04-13T22:29:03.753" v="299" actId="207"/>
          <ac:spMkLst>
            <pc:docMk/>
            <pc:sldMk cId="690432234" sldId="260"/>
            <ac:spMk id="47" creationId="{F88C1250-F20F-C412-0D9E-2E3C05C111AB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49" creationId="{C67BE316-C560-E952-24C2-A2AB2D35FAD5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2" creationId="{AD0D1B7C-E015-38CA-9E0D-0830D1CEAD41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7" creationId="{C3F66D08-04FC-B450-45D6-D5EAB784F035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8" creationId="{026650E4-C6A4-2082-4D3A-D1D8826C406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59" creationId="{885630B4-6ECE-67C3-6957-187379B017B0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60" creationId="{986757F1-CB49-3851-5C51-5BAC0E96E8D2}"/>
          </ac:spMkLst>
        </pc:spChg>
        <pc:spChg chg="mod">
          <ac:chgData name="Chung, Stephanie (NIH/NIDDK) [E]" userId="67f14949-e182-4972-adac-385ab37da48c" providerId="ADAL" clId="{96E13644-D5DB-4B92-A4D3-5CB16361942D}" dt="2025-04-13T22:28:22.370" v="294" actId="2711"/>
          <ac:spMkLst>
            <pc:docMk/>
            <pc:sldMk cId="690432234" sldId="260"/>
            <ac:spMk id="62" creationId="{CA4A2F3C-0FED-0C31-DB5E-45C75C2BCAFD}"/>
          </ac:spMkLst>
        </pc:spChg>
        <pc:spChg chg="del mod">
          <ac:chgData name="Chung, Stephanie (NIH/NIDDK) [E]" userId="67f14949-e182-4972-adac-385ab37da48c" providerId="ADAL" clId="{96E13644-D5DB-4B92-A4D3-5CB16361942D}" dt="2025-04-13T22:29:08.842" v="300" actId="478"/>
          <ac:spMkLst>
            <pc:docMk/>
            <pc:sldMk cId="690432234" sldId="260"/>
            <ac:spMk id="64" creationId="{17D2BA5B-B799-2B8B-B2F2-588E65AD3C08}"/>
          </ac:spMkLst>
        </pc:spChg>
        <pc:spChg chg="del mod">
          <ac:chgData name="Chung, Stephanie (NIH/NIDDK) [E]" userId="67f14949-e182-4972-adac-385ab37da48c" providerId="ADAL" clId="{96E13644-D5DB-4B92-A4D3-5CB16361942D}" dt="2025-04-13T22:26:38.912" v="275" actId="478"/>
          <ac:spMkLst>
            <pc:docMk/>
            <pc:sldMk cId="690432234" sldId="260"/>
            <ac:spMk id="65" creationId="{3E996400-C06A-8EFA-4291-E4F788023A2B}"/>
          </ac:spMkLst>
        </pc:spChg>
        <pc:spChg chg="del mod">
          <ac:chgData name="Chung, Stephanie (NIH/NIDDK) [E]" userId="67f14949-e182-4972-adac-385ab37da48c" providerId="ADAL" clId="{96E13644-D5DB-4B92-A4D3-5CB16361942D}" dt="2025-04-13T22:27:21.204" v="284" actId="478"/>
          <ac:spMkLst>
            <pc:docMk/>
            <pc:sldMk cId="690432234" sldId="260"/>
            <ac:spMk id="66" creationId="{79E49986-689B-4BBE-D063-38283C922BFD}"/>
          </ac:spMkLst>
        </pc:spChg>
        <pc:grpChg chg="add mod">
          <ac:chgData name="Chung, Stephanie (NIH/NIDDK) [E]" userId="67f14949-e182-4972-adac-385ab37da48c" providerId="ADAL" clId="{96E13644-D5DB-4B92-A4D3-5CB16361942D}" dt="2025-04-13T22:29:25.908" v="309" actId="1037"/>
          <ac:grpSpMkLst>
            <pc:docMk/>
            <pc:sldMk cId="690432234" sldId="260"/>
            <ac:grpSpMk id="24" creationId="{972DEA50-E807-8B8C-D9C2-33BC8D801E0E}"/>
          </ac:grpSpMkLst>
        </pc:grpChg>
        <pc:cxnChg chg="mod">
          <ac:chgData name="Chung, Stephanie (NIH/NIDDK) [E]" userId="67f14949-e182-4972-adac-385ab37da48c" providerId="ADAL" clId="{96E13644-D5DB-4B92-A4D3-5CB16361942D}" dt="2025-04-13T22:23:44.322" v="193" actId="1076"/>
          <ac:cxnSpMkLst>
            <pc:docMk/>
            <pc:sldMk cId="690432234" sldId="260"/>
            <ac:cxnSpMk id="3" creationId="{5C5E694F-6921-8F2C-7546-EC535AB8308C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" creationId="{CB1A43BD-B14F-ABB1-C203-2B120AEF4065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0" creationId="{FAFE3D17-AC5B-31C4-B572-D9F6F121BD3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2" creationId="{5A922433-DC30-C429-2167-7EEAEE5BA995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4" creationId="{2F6C0D07-0B5A-C66E-A398-D989C7194096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6" creationId="{9988496A-D1FC-A24D-AF10-45D1085592E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7" creationId="{EAC149DF-668E-6B2B-89DF-E5AFBBC33570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19" creationId="{874074D1-7586-885D-82D7-499E5C34B15F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20" creationId="{B67DDECA-3B59-0DA2-9DDA-CA58C704B26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4" creationId="{244AD61D-700D-A0A0-0FEC-CCDE038DD99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6" creationId="{60C8D935-280F-87F2-66BE-21ECC4DD35F7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37" creationId="{6213AE5A-72F2-6A67-2D74-FCCCB886E2DF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0" creationId="{AE2F9DBD-FC0E-0ED1-15B2-57B28DDEFF00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3" creationId="{08B5A42C-625C-8F99-2024-3D31D50B79E2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48" creationId="{CDAD4BFB-A893-8CE4-D150-DC74E425CA2A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0" creationId="{F6C961E9-5771-BBC4-0804-8DF7733EB188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1" creationId="{68DE962C-043E-5494-D537-CC2AA35BBA99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3" creationId="{9CE38A8A-BDCD-F13F-0DC7-A202F30E9EE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4" creationId="{D87A7B3E-EC1B-0F66-2FE8-8684D6B4674E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5" creationId="{30B377D3-4EA5-B68C-9760-EEDF40E93C5B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56" creationId="{B388D2AA-4C05-827D-6E15-0957E78EF3B3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1" creationId="{217B282A-99E2-4B62-050C-68EC0D9018AD}"/>
          </ac:cxnSpMkLst>
        </pc:cxnChg>
        <pc:cxnChg chg="mod">
          <ac:chgData name="Chung, Stephanie (NIH/NIDDK) [E]" userId="67f14949-e182-4972-adac-385ab37da48c" providerId="ADAL" clId="{96E13644-D5DB-4B92-A4D3-5CB16361942D}" dt="2025-04-13T22:20:52.841" v="157" actId="164"/>
          <ac:cxnSpMkLst>
            <pc:docMk/>
            <pc:sldMk cId="690432234" sldId="260"/>
            <ac:cxnSpMk id="63" creationId="{C14C7FE3-88C4-7453-43D2-C358DBFB762A}"/>
          </ac:cxnSpMkLst>
        </pc:cxnChg>
      </pc:sldChg>
      <pc:sldChg chg="add del ord">
        <pc:chgData name="Chung, Stephanie (NIH/NIDDK) [E]" userId="67f14949-e182-4972-adac-385ab37da48c" providerId="ADAL" clId="{96E13644-D5DB-4B92-A4D3-5CB16361942D}" dt="2025-04-13T22:18:28.087" v="127" actId="47"/>
        <pc:sldMkLst>
          <pc:docMk/>
          <pc:sldMk cId="1127047379" sldId="260"/>
        </pc:sldMkLst>
      </pc:sldChg>
      <pc:sldMasterChg chg="modSp modSldLayout">
        <pc:chgData name="Chung, Stephanie (NIH/NIDDK) [E]" userId="67f14949-e182-4972-adac-385ab37da48c" providerId="ADAL" clId="{96E13644-D5DB-4B92-A4D3-5CB16361942D}" dt="2025-04-13T21:41:55.401" v="49"/>
        <pc:sldMasterMkLst>
          <pc:docMk/>
          <pc:sldMasterMk cId="3978593516" sldId="2147483660"/>
        </pc:sldMasterMkLst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2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3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4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5" creationId="{00000000-0000-0000-0000-000000000000}"/>
          </ac:spMkLst>
        </pc:spChg>
        <pc:spChg chg="mod">
          <ac:chgData name="Chung, Stephanie (NIH/NIDDK) [E]" userId="67f14949-e182-4972-adac-385ab37da48c" providerId="ADAL" clId="{96E13644-D5DB-4B92-A4D3-5CB16361942D}" dt="2025-04-13T21:41:55.401" v="49"/>
          <ac:spMkLst>
            <pc:docMk/>
            <pc:sldMasterMk cId="3978593516" sldId="2147483660"/>
            <ac:spMk id="6" creationId="{00000000-0000-0000-0000-000000000000}"/>
          </ac:spMkLst>
        </pc:sp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072920937" sldId="2147483661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072920937" sldId="2147483661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072920937" sldId="2147483661"/>
              <ac:spMk id="3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2026823514" sldId="2147483663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026823514" sldId="2147483663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026823514" sldId="2147483663"/>
              <ac:spMk id="3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1924428051" sldId="2147483664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1924428051" sldId="2147483664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1924428051" sldId="2147483664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183848783" sldId="2147483665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4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5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183848783" sldId="2147483665"/>
              <ac:spMk id="6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760612395" sldId="2147483668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760612395" sldId="2147483668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2650198897" sldId="2147483669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3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2650198897" sldId="2147483669"/>
              <ac:spMk id="4" creationId="{00000000-0000-0000-0000-000000000000}"/>
            </ac:spMkLst>
          </pc:spChg>
        </pc:sldLayoutChg>
        <pc:sldLayoutChg chg="modSp">
          <pc:chgData name="Chung, Stephanie (NIH/NIDDK) [E]" userId="67f14949-e182-4972-adac-385ab37da48c" providerId="ADAL" clId="{96E13644-D5DB-4B92-A4D3-5CB16361942D}" dt="2025-04-13T21:41:55.401" v="49"/>
          <pc:sldLayoutMkLst>
            <pc:docMk/>
            <pc:sldMasterMk cId="3978593516" sldId="2147483660"/>
            <pc:sldLayoutMk cId="3811725813" sldId="2147483671"/>
          </pc:sldLayoutMkLst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811725813" sldId="2147483671"/>
              <ac:spMk id="2" creationId="{00000000-0000-0000-0000-000000000000}"/>
            </ac:spMkLst>
          </pc:spChg>
          <pc:spChg chg="mod">
            <ac:chgData name="Chung, Stephanie (NIH/NIDDK) [E]" userId="67f14949-e182-4972-adac-385ab37da48c" providerId="ADAL" clId="{96E13644-D5DB-4B92-A4D3-5CB16361942D}" dt="2025-04-13T21:41:55.401" v="49"/>
            <ac:spMkLst>
              <pc:docMk/>
              <pc:sldMasterMk cId="3978593516" sldId="2147483660"/>
              <pc:sldLayoutMk cId="3811725813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3B1A0-A823-4EC1-843E-1032505B1D7E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F9A92-81B3-43A6-B9DA-598E7A917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861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4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7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736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74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0" y="486834"/>
            <a:ext cx="35052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0" y="486834"/>
            <a:ext cx="103124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596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198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2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5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82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2434167"/>
            <a:ext cx="69088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2434167"/>
            <a:ext cx="69088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44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486834"/>
            <a:ext cx="140208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8" y="2241551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8" y="3340100"/>
            <a:ext cx="687704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0" y="2241551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0" y="3340100"/>
            <a:ext cx="691091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43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970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248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316567"/>
            <a:ext cx="82296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56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316567"/>
            <a:ext cx="82296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599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486834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082A4-B690-4C79-AAFE-049CEA5ACC07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8475134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E713A-8195-4B24-8A79-6258E9B449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07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5BA8610-A04E-EED4-009E-CD1248C42C2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455DD46-0F20-6D92-06F7-7CFEEA95C101}"/>
              </a:ext>
            </a:extLst>
          </p:cNvPr>
          <p:cNvSpPr txBox="1">
            <a:spLocks noChangeAspect="1"/>
          </p:cNvSpPr>
          <p:nvPr/>
        </p:nvSpPr>
        <p:spPr>
          <a:xfrm>
            <a:off x="414632" y="305196"/>
            <a:ext cx="15269868" cy="1077218"/>
          </a:xfrm>
          <a:prstGeom prst="rect">
            <a:avLst/>
          </a:prstGeom>
          <a:solidFill>
            <a:schemeClr val="bg1"/>
          </a:solidFill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r>
              <a:rPr lang="en-US" sz="3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2: Unadjusted 35-year i3C Combined Risk Z-Score and Hazard Ratio for Predicted Cardiovascular Events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85597B-1E72-5070-8A12-0504CE8D7A22}"/>
              </a:ext>
            </a:extLst>
          </p:cNvPr>
          <p:cNvSpPr txBox="1"/>
          <p:nvPr/>
        </p:nvSpPr>
        <p:spPr>
          <a:xfrm>
            <a:off x="952500" y="2244031"/>
            <a:ext cx="6959600" cy="707886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2A. i3C Combined Risk Z-Score </a:t>
            </a:r>
          </a:p>
          <a:p>
            <a:pPr algn="ctr"/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 Diagnosis Grou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F02895-806A-7D0E-DDA5-9E4BC97CC173}"/>
              </a:ext>
            </a:extLst>
          </p:cNvPr>
          <p:cNvSpPr txBox="1"/>
          <p:nvPr/>
        </p:nvSpPr>
        <p:spPr>
          <a:xfrm>
            <a:off x="8944618" y="2258099"/>
            <a:ext cx="5699202" cy="707886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2B. i3C Derived Hazard Ratio </a:t>
            </a:r>
          </a:p>
          <a:p>
            <a:pPr algn="ctr"/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 Diagnosis Grou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3A23A5-AD76-6947-486E-46B98C622341}"/>
              </a:ext>
            </a:extLst>
          </p:cNvPr>
          <p:cNvSpPr txBox="1"/>
          <p:nvPr/>
        </p:nvSpPr>
        <p:spPr>
          <a:xfrm>
            <a:off x="952500" y="8038685"/>
            <a:ext cx="9245600" cy="830997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are Mean (95% Confidence Interval)</a:t>
            </a:r>
            <a:endParaRPr lang="en-US" sz="1600" b="1" i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alue for Bonferroni multiplicity correction &lt; 0.016</a:t>
            </a:r>
          </a:p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-T2D: youth-onset type 2 diabetes; OW/OB: overweight/obesity</a:t>
            </a:r>
          </a:p>
        </p:txBody>
      </p:sp>
      <p:pic>
        <p:nvPicPr>
          <p:cNvPr id="22" name="Picture 21" descr="Chart&#10;&#10;AI-generated content may be incorrect.">
            <a:extLst>
              <a:ext uri="{FF2B5EF4-FFF2-40B4-BE49-F238E27FC236}">
                <a16:creationId xmlns:a16="http://schemas.microsoft.com/office/drawing/2014/main" id="{1B95D5EC-DD62-81F5-01B2-DAC4824099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0508" y="3316558"/>
            <a:ext cx="5433386" cy="4162562"/>
          </a:xfrm>
          <a:prstGeom prst="rect">
            <a:avLst/>
          </a:prstGeom>
        </p:spPr>
      </p:pic>
      <p:pic>
        <p:nvPicPr>
          <p:cNvPr id="24" name="Picture 23" descr="Chart&#10;&#10;AI-generated content may be incorrect.">
            <a:extLst>
              <a:ext uri="{FF2B5EF4-FFF2-40B4-BE49-F238E27FC236}">
                <a16:creationId xmlns:a16="http://schemas.microsoft.com/office/drawing/2014/main" id="{B3C8EABF-8DC3-542F-5D02-191E3879B5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3757" y="3281369"/>
            <a:ext cx="5433386" cy="415205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9DB9B58-BB5A-0B2B-570E-526F05136EBE}"/>
              </a:ext>
            </a:extLst>
          </p:cNvPr>
          <p:cNvSpPr txBox="1"/>
          <p:nvPr/>
        </p:nvSpPr>
        <p:spPr>
          <a:xfrm>
            <a:off x="1955977" y="5810649"/>
            <a:ext cx="2251631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0.08 (-0.12, -0.03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E785BB4-1A27-6B81-188F-7D18673E4301}"/>
              </a:ext>
            </a:extLst>
          </p:cNvPr>
          <p:cNvSpPr txBox="1"/>
          <p:nvPr/>
        </p:nvSpPr>
        <p:spPr>
          <a:xfrm>
            <a:off x="2988158" y="4865047"/>
            <a:ext cx="213260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4 (0.80, 0.88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C81850B-4B88-CA86-55BE-B3F10E4C121B}"/>
              </a:ext>
            </a:extLst>
          </p:cNvPr>
          <p:cNvSpPr txBox="1"/>
          <p:nvPr/>
        </p:nvSpPr>
        <p:spPr>
          <a:xfrm>
            <a:off x="3343549" y="3681505"/>
            <a:ext cx="213260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8 (0.97, 1.18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16B4A9-0D67-CE77-619E-07739F44B151}"/>
              </a:ext>
            </a:extLst>
          </p:cNvPr>
          <p:cNvSpPr txBox="1"/>
          <p:nvPr/>
        </p:nvSpPr>
        <p:spPr>
          <a:xfrm>
            <a:off x="9468288" y="5838342"/>
            <a:ext cx="213260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 (0.80, 1.21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56B6EE-6468-31FB-E477-36A72A114F4B}"/>
              </a:ext>
            </a:extLst>
          </p:cNvPr>
          <p:cNvSpPr txBox="1"/>
          <p:nvPr/>
        </p:nvSpPr>
        <p:spPr>
          <a:xfrm>
            <a:off x="10284313" y="4886352"/>
            <a:ext cx="213260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07 (2.89, 3.25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16FCB0F-FB48-63C5-6753-8D492E9D8C69}"/>
              </a:ext>
            </a:extLst>
          </p:cNvPr>
          <p:cNvSpPr txBox="1"/>
          <p:nvPr/>
        </p:nvSpPr>
        <p:spPr>
          <a:xfrm>
            <a:off x="10615417" y="3730882"/>
            <a:ext cx="213260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77 (3.29, 4.25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C80410-8DBB-C890-C4CB-A82C02DF3F5D}"/>
              </a:ext>
            </a:extLst>
          </p:cNvPr>
          <p:cNvSpPr txBox="1"/>
          <p:nvPr/>
        </p:nvSpPr>
        <p:spPr>
          <a:xfrm>
            <a:off x="1181227" y="3757069"/>
            <a:ext cx="933062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-T2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31C9DA-EA98-E0F7-57F3-FAC1917AB2DE}"/>
              </a:ext>
            </a:extLst>
          </p:cNvPr>
          <p:cNvSpPr txBox="1"/>
          <p:nvPr/>
        </p:nvSpPr>
        <p:spPr>
          <a:xfrm>
            <a:off x="933639" y="4925627"/>
            <a:ext cx="1212289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W/O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40B0A6-0E13-3E6B-8771-20E24BB99F2F}"/>
              </a:ext>
            </a:extLst>
          </p:cNvPr>
          <p:cNvSpPr txBox="1"/>
          <p:nvPr/>
        </p:nvSpPr>
        <p:spPr>
          <a:xfrm>
            <a:off x="1205908" y="6040159"/>
            <a:ext cx="91745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66A7D3-CA42-34F6-CFAF-0CDBD40D3ED2}"/>
              </a:ext>
            </a:extLst>
          </p:cNvPr>
          <p:cNvSpPr txBox="1"/>
          <p:nvPr/>
        </p:nvSpPr>
        <p:spPr>
          <a:xfrm>
            <a:off x="8770565" y="3808644"/>
            <a:ext cx="933062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-T2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03115A5-CD96-8295-649E-0C18C14B37AF}"/>
              </a:ext>
            </a:extLst>
          </p:cNvPr>
          <p:cNvSpPr txBox="1"/>
          <p:nvPr/>
        </p:nvSpPr>
        <p:spPr>
          <a:xfrm>
            <a:off x="8539468" y="4940454"/>
            <a:ext cx="1212289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W/O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B584B05-F7C8-AEA7-74E7-B16AC1984BF8}"/>
              </a:ext>
            </a:extLst>
          </p:cNvPr>
          <p:cNvSpPr txBox="1"/>
          <p:nvPr/>
        </p:nvSpPr>
        <p:spPr>
          <a:xfrm>
            <a:off x="8824989" y="6080939"/>
            <a:ext cx="917455" cy="338554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>
            <a:defPPr>
              <a:defRPr kern="1200"/>
            </a:defPPr>
          </a:lstStyle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n</a:t>
            </a:r>
          </a:p>
        </p:txBody>
      </p:sp>
    </p:spTree>
    <p:extLst>
      <p:ext uri="{BB962C8B-B14F-4D97-AF65-F5344CB8AC3E}">
        <p14:creationId xmlns:p14="http://schemas.microsoft.com/office/powerpoint/2010/main" val="2234938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646</TotalTime>
  <Words>116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i3C Manuscript</dc:title>
  <dc:creator>Davis, Faith (NIH/NIDDK) [F]</dc:creator>
  <cp:lastModifiedBy>Malandrino, Noemi (NIH/NIDDK) [E]</cp:lastModifiedBy>
  <cp:revision>35</cp:revision>
  <dcterms:created xsi:type="dcterms:W3CDTF">2024-07-08T14:19:43Z</dcterms:created>
  <dcterms:modified xsi:type="dcterms:W3CDTF">2025-09-11T22:26:12Z</dcterms:modified>
</cp:coreProperties>
</file>